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70" d="100"/>
          <a:sy n="70" d="100"/>
        </p:scale>
        <p:origin x="738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nna Johnsson" userId="ef1be37a-598e-4638-b9ed-50fc583bda9b" providerId="ADAL" clId="{2B4C079C-2FD2-4C7B-986D-B3EC264B430F}"/>
    <pc:docChg chg="modSld">
      <pc:chgData name="Hanna Johnsson" userId="ef1be37a-598e-4638-b9ed-50fc583bda9b" providerId="ADAL" clId="{2B4C079C-2FD2-4C7B-986D-B3EC264B430F}" dt="2022-11-08T12:13:02.264" v="16" actId="20577"/>
      <pc:docMkLst>
        <pc:docMk/>
      </pc:docMkLst>
      <pc:sldChg chg="modSp mod">
        <pc:chgData name="Hanna Johnsson" userId="ef1be37a-598e-4638-b9ed-50fc583bda9b" providerId="ADAL" clId="{2B4C079C-2FD2-4C7B-986D-B3EC264B430F}" dt="2022-11-08T12:13:02.264" v="16" actId="20577"/>
        <pc:sldMkLst>
          <pc:docMk/>
          <pc:sldMk cId="1675754173" sldId="257"/>
        </pc:sldMkLst>
        <pc:spChg chg="mod">
          <ac:chgData name="Hanna Johnsson" userId="ef1be37a-598e-4638-b9ed-50fc583bda9b" providerId="ADAL" clId="{2B4C079C-2FD2-4C7B-986D-B3EC264B430F}" dt="2022-11-08T12:13:02.264" v="16" actId="20577"/>
          <ac:spMkLst>
            <pc:docMk/>
            <pc:sldMk cId="1675754173" sldId="257"/>
            <ac:spMk id="22" creationId="{B4C5DADC-0238-6B78-285B-F89BF6195FDA}"/>
          </ac:spMkLst>
        </pc:spChg>
      </pc:sldChg>
    </pc:docChg>
  </pc:docChgLst>
  <pc:docChgLst>
    <pc:chgData name="Hanna Johnsson" userId="ef1be37a-598e-4638-b9ed-50fc583bda9b" providerId="ADAL" clId="{4E8D18B8-7CDF-4102-9631-115B530BCC9D}"/>
    <pc:docChg chg="delSld modSld">
      <pc:chgData name="Hanna Johnsson" userId="ef1be37a-598e-4638-b9ed-50fc583bda9b" providerId="ADAL" clId="{4E8D18B8-7CDF-4102-9631-115B530BCC9D}" dt="2022-08-11T21:14:38.726" v="1" actId="20577"/>
      <pc:docMkLst>
        <pc:docMk/>
      </pc:docMkLst>
      <pc:sldChg chg="modSp mod">
        <pc:chgData name="Hanna Johnsson" userId="ef1be37a-598e-4638-b9ed-50fc583bda9b" providerId="ADAL" clId="{4E8D18B8-7CDF-4102-9631-115B530BCC9D}" dt="2022-08-11T21:14:38.726" v="1" actId="20577"/>
        <pc:sldMkLst>
          <pc:docMk/>
          <pc:sldMk cId="1675754173" sldId="257"/>
        </pc:sldMkLst>
        <pc:spChg chg="mod">
          <ac:chgData name="Hanna Johnsson" userId="ef1be37a-598e-4638-b9ed-50fc583bda9b" providerId="ADAL" clId="{4E8D18B8-7CDF-4102-9631-115B530BCC9D}" dt="2022-08-11T21:14:38.726" v="1" actId="20577"/>
          <ac:spMkLst>
            <pc:docMk/>
            <pc:sldMk cId="1675754173" sldId="257"/>
            <ac:spMk id="22" creationId="{B4C5DADC-0238-6B78-285B-F89BF6195FDA}"/>
          </ac:spMkLst>
        </pc:spChg>
      </pc:sldChg>
      <pc:sldChg chg="del">
        <pc:chgData name="Hanna Johnsson" userId="ef1be37a-598e-4638-b9ed-50fc583bda9b" providerId="ADAL" clId="{4E8D18B8-7CDF-4102-9631-115B530BCC9D}" dt="2022-08-11T21:10:45.388" v="0" actId="2696"/>
        <pc:sldMkLst>
          <pc:docMk/>
          <pc:sldMk cId="963384149" sldId="271"/>
        </pc:sldMkLst>
      </pc:sldChg>
    </pc:docChg>
  </pc:docChgLst>
  <pc:docChgLst>
    <pc:chgData name="Hanna Johnsson" userId="ef1be37a-598e-4638-b9ed-50fc583bda9b" providerId="ADAL" clId="{8CB0DB01-E255-4E8D-B94D-2AB056A39BA4}"/>
    <pc:docChg chg="custSel addSld modSld">
      <pc:chgData name="Hanna Johnsson" userId="ef1be37a-598e-4638-b9ed-50fc583bda9b" providerId="ADAL" clId="{8CB0DB01-E255-4E8D-B94D-2AB056A39BA4}" dt="2022-07-26T06:19:29.811" v="20" actId="1076"/>
      <pc:docMkLst>
        <pc:docMk/>
      </pc:docMkLst>
      <pc:sldChg chg="addSp delSp modSp mod">
        <pc:chgData name="Hanna Johnsson" userId="ef1be37a-598e-4638-b9ed-50fc583bda9b" providerId="ADAL" clId="{8CB0DB01-E255-4E8D-B94D-2AB056A39BA4}" dt="2022-07-26T06:19:21.876" v="18" actId="21"/>
        <pc:sldMkLst>
          <pc:docMk/>
          <pc:sldMk cId="1675754173" sldId="257"/>
        </pc:sldMkLst>
        <pc:spChg chg="add del mod">
          <ac:chgData name="Hanna Johnsson" userId="ef1be37a-598e-4638-b9ed-50fc583bda9b" providerId="ADAL" clId="{8CB0DB01-E255-4E8D-B94D-2AB056A39BA4}" dt="2022-07-26T06:19:21.876" v="18" actId="21"/>
          <ac:spMkLst>
            <pc:docMk/>
            <pc:sldMk cId="1675754173" sldId="257"/>
            <ac:spMk id="5" creationId="{D5C28ED8-5AB9-02BC-3453-F55C7124D873}"/>
          </ac:spMkLst>
        </pc:spChg>
        <pc:spChg chg="mod">
          <ac:chgData name="Hanna Johnsson" userId="ef1be37a-598e-4638-b9ed-50fc583bda9b" providerId="ADAL" clId="{8CB0DB01-E255-4E8D-B94D-2AB056A39BA4}" dt="2022-07-26T06:18:02.823" v="1" actId="1076"/>
          <ac:spMkLst>
            <pc:docMk/>
            <pc:sldMk cId="1675754173" sldId="257"/>
            <ac:spMk id="22" creationId="{B4C5DADC-0238-6B78-285B-F89BF6195FDA}"/>
          </ac:spMkLst>
        </pc:spChg>
        <pc:graphicFrameChg chg="add del mod">
          <ac:chgData name="Hanna Johnsson" userId="ef1be37a-598e-4638-b9ed-50fc583bda9b" providerId="ADAL" clId="{8CB0DB01-E255-4E8D-B94D-2AB056A39BA4}" dt="2022-07-26T06:19:07.448" v="14" actId="21"/>
          <ac:graphicFrameMkLst>
            <pc:docMk/>
            <pc:sldMk cId="1675754173" sldId="257"/>
            <ac:graphicFrameMk id="4" creationId="{542FFDB7-6DF2-6C54-D1D2-27309ABF049D}"/>
          </ac:graphicFrameMkLst>
        </pc:graphicFrameChg>
      </pc:sldChg>
      <pc:sldChg chg="addSp delSp modSp add mod">
        <pc:chgData name="Hanna Johnsson" userId="ef1be37a-598e-4638-b9ed-50fc583bda9b" providerId="ADAL" clId="{8CB0DB01-E255-4E8D-B94D-2AB056A39BA4}" dt="2022-07-26T06:19:29.811" v="20" actId="1076"/>
        <pc:sldMkLst>
          <pc:docMk/>
          <pc:sldMk cId="963384149" sldId="271"/>
        </pc:sldMkLst>
        <pc:spChg chg="del">
          <ac:chgData name="Hanna Johnsson" userId="ef1be37a-598e-4638-b9ed-50fc583bda9b" providerId="ADAL" clId="{8CB0DB01-E255-4E8D-B94D-2AB056A39BA4}" dt="2022-07-26T06:19:16.174" v="17" actId="478"/>
          <ac:spMkLst>
            <pc:docMk/>
            <pc:sldMk cId="963384149" sldId="271"/>
            <ac:spMk id="2" creationId="{B223F3CD-2445-447A-9B32-2E8BB82AC8AE}"/>
          </ac:spMkLst>
        </pc:spChg>
        <pc:spChg chg="del mod">
          <ac:chgData name="Hanna Johnsson" userId="ef1be37a-598e-4638-b9ed-50fc583bda9b" providerId="ADAL" clId="{8CB0DB01-E255-4E8D-B94D-2AB056A39BA4}" dt="2022-07-26T06:18:37.704" v="8" actId="21"/>
          <ac:spMkLst>
            <pc:docMk/>
            <pc:sldMk cId="963384149" sldId="271"/>
            <ac:spMk id="5" creationId="{5C26E6D6-E0D1-49BE-A7B4-6F65F68AE909}"/>
          </ac:spMkLst>
        </pc:spChg>
        <pc:spChg chg="add mod">
          <ac:chgData name="Hanna Johnsson" userId="ef1be37a-598e-4638-b9ed-50fc583bda9b" providerId="ADAL" clId="{8CB0DB01-E255-4E8D-B94D-2AB056A39BA4}" dt="2022-07-26T06:19:29.811" v="20" actId="1076"/>
          <ac:spMkLst>
            <pc:docMk/>
            <pc:sldMk cId="963384149" sldId="271"/>
            <ac:spMk id="7" creationId="{873CBEA4-9E8E-B2CE-5600-839748932E6F}"/>
          </ac:spMkLst>
        </pc:spChg>
        <pc:graphicFrameChg chg="del">
          <ac:chgData name="Hanna Johnsson" userId="ef1be37a-598e-4638-b9ed-50fc583bda9b" providerId="ADAL" clId="{8CB0DB01-E255-4E8D-B94D-2AB056A39BA4}" dt="2022-07-26T06:18:05.843" v="2" actId="21"/>
          <ac:graphicFrameMkLst>
            <pc:docMk/>
            <pc:sldMk cId="963384149" sldId="271"/>
            <ac:graphicFrameMk id="3" creationId="{8C7D6A5C-5A68-45EB-8873-0E7A541BED82}"/>
          </ac:graphicFrameMkLst>
        </pc:graphicFrameChg>
        <pc:graphicFrameChg chg="add mod">
          <ac:chgData name="Hanna Johnsson" userId="ef1be37a-598e-4638-b9ed-50fc583bda9b" providerId="ADAL" clId="{8CB0DB01-E255-4E8D-B94D-2AB056A39BA4}" dt="2022-07-26T06:19:13.137" v="16" actId="1076"/>
          <ac:graphicFrameMkLst>
            <pc:docMk/>
            <pc:sldMk cId="963384149" sldId="271"/>
            <ac:graphicFrameMk id="6" creationId="{E594A368-76F0-D1D0-20F2-035A6D041036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F2E7E2-9C96-9239-BED8-50A4A222C8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CA9960D-A9C2-DE84-7711-90D3F4EDF4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CBC955-CD2A-EEBE-E3EA-DAB1195221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57700-9280-4F5A-8A9E-5C0C810F3AE7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DDA38D-A40B-6418-9F6E-8DF8B9E58A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1FEC5E-0319-5361-1D84-640AB24648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41B56-ADA0-44C9-A8F6-DE1F76D3C7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7884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85203D-6433-1865-C6FC-4DE1F64DBF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5228A8-ABE6-4AB3-3D1A-C9C8D743F0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4B9B0A-272C-ACD5-4658-EB014AA733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57700-9280-4F5A-8A9E-5C0C810F3AE7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510FB7-3024-2582-26E1-CC4CC83455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5468FD-FE13-61CA-87CF-D744A82D9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41B56-ADA0-44C9-A8F6-DE1F76D3C7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2752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B037C13-A813-6532-A636-447A4EC985A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597D36-2EBE-6843-D8EF-F81A396EF1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66277A-DFF4-EACA-D5F5-1143FE01D0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57700-9280-4F5A-8A9E-5C0C810F3AE7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4E9544-4E8E-69F8-73AA-8A17A4F291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0016A7-511B-A0B2-FEB9-C38C4BB8D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41B56-ADA0-44C9-A8F6-DE1F76D3C7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1448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CB46A4-3BCE-9633-2378-E68199F1CE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5ED450-992B-5E5C-351E-0D613A18A9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D5BD1E-90AA-F0F4-694F-A95390947E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57700-9280-4F5A-8A9E-5C0C810F3AE7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E07A59-1A8D-F3A0-A9EF-2AA7C843B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2B5631-0549-294A-16F3-0BD9552B0C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41B56-ADA0-44C9-A8F6-DE1F76D3C7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9826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F7798-409F-71F1-57D8-350445C877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C836D5-9331-46E5-01C7-D8A0D3BFCC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24D36B-8265-206A-3B1D-5ABFF8E383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57700-9280-4F5A-8A9E-5C0C810F3AE7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98C8D0-24F1-941E-4F7C-AB55F4F27B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61B0E0-9308-5A9D-5F79-40D9E90F2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41B56-ADA0-44C9-A8F6-DE1F76D3C7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6086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534B65-ECD9-FB92-F6EC-970F724E5D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61413B-9D62-07E1-DAFA-4C12E5704A1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D831EA-D542-F1C5-E0AA-999E90CF40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472324-3BF4-06CB-26FD-6C00B88674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57700-9280-4F5A-8A9E-5C0C810F3AE7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1DC915-5F9F-235D-670E-E14214AEFA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3B74BB-E9FF-BE97-F513-214704523F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41B56-ADA0-44C9-A8F6-DE1F76D3C7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06655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C711FC-0D97-4579-E850-E85DF7C5BC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86CF4B-9C8A-CD6B-4D8D-126D8AA616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94EF3BB-7608-EF3A-7F9C-C28EAD575C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87C6F19-E10A-491F-F8C3-90085D002C1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305151B-A3C9-B274-728C-C61572C4CED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CB0B3B8-8CCC-444C-42D7-B5F4C8ABDE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57700-9280-4F5A-8A9E-5C0C810F3AE7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F0B31F7-A41B-D1CB-575E-8CCD16EF7C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EF3E8D7-C0CC-87E6-82FA-FF0CDA0EFE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41B56-ADA0-44C9-A8F6-DE1F76D3C7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9026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0C95F0-848F-1606-EF9F-E80D77BDB5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A1BD5CC-5E97-168A-33B6-157A3E5FE3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57700-9280-4F5A-8A9E-5C0C810F3AE7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D238102-07D0-3B50-DEB9-F4A7F29AD9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8147700-9EFA-191F-180A-D403D7C223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41B56-ADA0-44C9-A8F6-DE1F76D3C7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2287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51FA428-4E14-D550-187F-1E5F32D5BB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57700-9280-4F5A-8A9E-5C0C810F3AE7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C7B7159-FD9A-6119-35F1-AFAC9724F0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407A9A8-276D-33B4-381B-8AD3684EE6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41B56-ADA0-44C9-A8F6-DE1F76D3C7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4666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76AF10-D3E0-A0F1-91A2-8F89C8395A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52F32D-2645-A3B5-A424-7F1C6398DE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BEDBF3-19BC-94B6-5158-8E73355688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34CA27-9CEB-DA97-9222-9B54CE7C19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57700-9280-4F5A-8A9E-5C0C810F3AE7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11A2D9-05B9-4F73-1478-FFF64D4770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8D6974-1942-7E68-7A4D-63558B01BF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41B56-ADA0-44C9-A8F6-DE1F76D3C7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4671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7FCBCF-2CB5-7A33-2936-CCD1A2B6F3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CC54C8F-933A-DB0C-3541-291FD3FF40B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05CB6D-A71F-5FD5-2F2D-8DB46D989C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B54489-0592-055B-E377-7E8BE3F809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57700-9280-4F5A-8A9E-5C0C810F3AE7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197B29-9C6A-F417-E1BA-263A31027C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D3D872-41A6-18CB-AB92-E8CC0172CF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41B56-ADA0-44C9-A8F6-DE1F76D3C7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31791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FE460FF-F4A3-C24F-29DA-24DC2E6C2B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1C90D8-3CF2-B660-6AD1-9EB34E908C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2D2B15-11D2-8912-4171-52853B88D3B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C57700-9280-4F5A-8A9E-5C0C810F3AE7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92A27D-CACE-8ED8-B214-743EC9AF08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C8190A-0E98-20D6-B04C-F4389AABBE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241B56-ADA0-44C9-A8F6-DE1F76D3C7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31834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Rectangle 6">
            <a:extLst>
              <a:ext uri="{FF2B5EF4-FFF2-40B4-BE49-F238E27FC236}">
                <a16:creationId xmlns:a16="http://schemas.microsoft.com/office/drawing/2014/main" id="{B4C5DADC-0238-6B78-285B-F89BF6195F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3463" y="2870087"/>
            <a:ext cx="8392896" cy="6001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 file 3. Differentially expressed genes in the GO </a:t>
            </a:r>
            <a:r>
              <a:rPr lang="en-GB" alt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eratinization </a:t>
            </a:r>
            <a:r>
              <a:rPr kumimoji="0" lang="en-GB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e set.</a:t>
            </a:r>
            <a:endParaRPr kumimoji="0" lang="en-GB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oxplots of DEGs (p</a:t>
            </a:r>
            <a:r>
              <a:rPr kumimoji="0" lang="en-GB" altLang="en-US" sz="1100" b="0" i="0" u="none" strike="noStrike" cap="none" normalizeH="0" baseline="-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j</a:t>
            </a:r>
            <a:r>
              <a:rPr kumimoji="0" lang="en-GB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&lt;0.05, absolute log</a:t>
            </a:r>
            <a:r>
              <a:rPr kumimoji="0" lang="en-GB" altLang="en-US" sz="1100" b="0" i="0" u="none" strike="noStrike" cap="none" normalizeH="0" baseline="-25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kumimoji="0" lang="en-GB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ld &gt;1) which form part of the </a:t>
            </a:r>
            <a:r>
              <a:rPr lang="en-GB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O </a:t>
            </a:r>
            <a:r>
              <a:rPr kumimoji="0" lang="en-GB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eratinization gene set when PsA skin lesions (PsA L) were compared to healthy control (HC) skin. G</a:t>
            </a:r>
            <a:r>
              <a:rPr kumimoji="0" lang="en-GB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nes are given on the x-axis and expression values </a:t>
            </a:r>
            <a:r>
              <a:rPr lang="en-GB" alt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kumimoji="0" lang="en-GB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r gene z-scores) on the y-axis. </a:t>
            </a:r>
            <a:endParaRPr kumimoji="0" lang="en-GB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36F8A925-4565-8058-9F19-7B8B8FC50F5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803" y="352215"/>
            <a:ext cx="11003280" cy="27523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57541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2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na Johnsson</dc:creator>
  <cp:lastModifiedBy>Hanna Johnsson</cp:lastModifiedBy>
  <cp:revision>1</cp:revision>
  <dcterms:created xsi:type="dcterms:W3CDTF">2022-07-21T20:50:27Z</dcterms:created>
  <dcterms:modified xsi:type="dcterms:W3CDTF">2022-11-08T12:13:10Z</dcterms:modified>
</cp:coreProperties>
</file>